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  <a:srgbClr val="FF00FF"/>
    <a:srgbClr val="0000FF"/>
    <a:srgbClr val="800000"/>
    <a:srgbClr val="6600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858" autoAdjust="0"/>
    <p:restoredTop sz="86810" autoAdjust="0"/>
  </p:normalViewPr>
  <p:slideViewPr>
    <p:cSldViewPr>
      <p:cViewPr varScale="1">
        <p:scale>
          <a:sx n="73" d="100"/>
          <a:sy n="73" d="100"/>
        </p:scale>
        <p:origin x="2274" y="5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5CF5F0-A185-432C-82C1-DB1F4BB881D7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368D9E-EFE5-4006-9788-5123A72728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42513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wego.genomics.org.cn/" TargetMode="External"/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3 Fig. Gene ontology (GO) assignments for all assembled </a:t>
            </a:r>
            <a:r>
              <a:rPr kumimoji="1" lang="en-US" altLang="ja-JP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igenes</a:t>
            </a:r>
            <a:r>
              <a:rPr kumimoji="1" lang="en-US" altLang="ja-JP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green </a:t>
            </a:r>
            <a:r>
              <a:rPr kumimoji="1" lang="en-US" altLang="ja-JP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rilla</a:t>
            </a:r>
            <a:r>
              <a:rPr kumimoji="1" lang="en-US" altLang="ja-JP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sults summarized in three functional categories: cellular component, molecular function, and biological process. 29,813 </a:t>
            </a:r>
            <a:r>
              <a:rPr kumimoji="1" lang="en-US" altLang="ja-JP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igenes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ere categorized by GO terms. The GO terms were visualized using WEGO (</a:t>
            </a:r>
            <a:r>
              <a:rPr kumimoji="1" lang="en-US" altLang="ja-JP" sz="1200" u="sng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3"/>
              </a:rPr>
              <a:t>http://wego.genomics.org.cn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[39].</a:t>
            </a:r>
            <a:endParaRPr kumimoji="1" lang="ja-JP" altLang="ja-JP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F368D9E-EFE5-4006-9788-5123A727280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2453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グループ化 7"/>
          <p:cNvGrpSpPr/>
          <p:nvPr/>
        </p:nvGrpSpPr>
        <p:grpSpPr>
          <a:xfrm>
            <a:off x="576523" y="1115616"/>
            <a:ext cx="5516773" cy="4306664"/>
            <a:chOff x="576523" y="1115616"/>
            <a:chExt cx="5516773" cy="4306664"/>
          </a:xfrm>
        </p:grpSpPr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6523" y="1203642"/>
              <a:ext cx="5516773" cy="38004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テキスト ボックス 4"/>
            <p:cNvSpPr txBox="1"/>
            <p:nvPr/>
          </p:nvSpPr>
          <p:spPr>
            <a:xfrm>
              <a:off x="815857" y="4960615"/>
              <a:ext cx="115212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ellular component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2060848" y="4960615"/>
              <a:ext cx="115212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lecular function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3645024" y="4960615"/>
              <a:ext cx="115212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iological process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テキスト ボックス 1"/>
            <p:cNvSpPr txBox="1"/>
            <p:nvPr/>
          </p:nvSpPr>
          <p:spPr>
            <a:xfrm>
              <a:off x="4994126" y="1115616"/>
              <a:ext cx="941283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ja-JP" sz="1400" dirty="0" err="1" smtClean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endParaRPr kumimoji="1" lang="ja-JP" altLang="en-US" sz="14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 rot="16200000">
              <a:off x="5188390" y="2010910"/>
              <a:ext cx="1503784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umber of genes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 rot="16200000">
              <a:off x="175199" y="2094617"/>
              <a:ext cx="1150443" cy="276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% of genes         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 rot="16200000">
              <a:off x="839925" y="1876585"/>
              <a:ext cx="224407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" name="テキスト ボックス 12"/>
          <p:cNvSpPr txBox="1"/>
          <p:nvPr/>
        </p:nvSpPr>
        <p:spPr>
          <a:xfrm>
            <a:off x="2973705" y="1115616"/>
            <a:ext cx="1152128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evel 2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2132856" y="8774668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Fukushima et al. S3 Fig.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72346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5</TotalTime>
  <Words>80</Words>
  <Application>Microsoft Office PowerPoint</Application>
  <PresentationFormat>画面に合わせる (4:3)</PresentationFormat>
  <Paragraphs>1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ku</dc:creator>
  <cp:lastModifiedBy>fuku</cp:lastModifiedBy>
  <cp:revision>181</cp:revision>
  <dcterms:created xsi:type="dcterms:W3CDTF">2014-12-01T05:59:03Z</dcterms:created>
  <dcterms:modified xsi:type="dcterms:W3CDTF">2015-05-12T03:59:47Z</dcterms:modified>
</cp:coreProperties>
</file>